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6480175" cy="5400675"/>
  <p:notesSz cx="6858000" cy="9144000"/>
  <p:defaultTextStyle>
    <a:defPPr>
      <a:defRPr lang="en-US"/>
    </a:defPPr>
    <a:lvl1pPr marL="0" algn="l" defTabSz="373624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1pPr>
    <a:lvl2pPr marL="373624" algn="l" defTabSz="373624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2pPr>
    <a:lvl3pPr marL="747248" algn="l" defTabSz="373624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3pPr>
    <a:lvl4pPr marL="1120872" algn="l" defTabSz="373624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4pPr>
    <a:lvl5pPr marL="1494495" algn="l" defTabSz="373624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5pPr>
    <a:lvl6pPr marL="1868119" algn="l" defTabSz="373624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6pPr>
    <a:lvl7pPr marL="2241743" algn="l" defTabSz="373624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7pPr>
    <a:lvl8pPr marL="2615367" algn="l" defTabSz="373624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8pPr>
    <a:lvl9pPr marL="2988991" algn="l" defTabSz="373624" rtl="0" eaLnBrk="1" latinLnBrk="0" hangingPunct="1">
      <a:defRPr sz="147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714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%20Emri%20Tam&#225;s\Desktop\Claudia%20Afumi\help%20for%20figures%20and%20tables\Fig%20S1%20PCA%20fumi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hu-H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Munka1!$C$5</c:f>
              <c:strCache>
                <c:ptCount val="1"/>
                <c:pt idx="0">
                  <c:v>PC2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1"/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3"/>
            <c:marker>
              <c:symbol val="circle"/>
              <c:size val="8"/>
              <c:spPr>
                <a:solidFill>
                  <a:srgbClr val="00B05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9133-4D4C-B155-0BF89F8B6D51}"/>
              </c:ext>
            </c:extLst>
          </c:dPt>
          <c:dPt>
            <c:idx val="4"/>
            <c:marker>
              <c:symbol val="circle"/>
              <c:size val="8"/>
              <c:spPr>
                <a:solidFill>
                  <a:srgbClr val="00B05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9133-4D4C-B155-0BF89F8B6D51}"/>
              </c:ext>
            </c:extLst>
          </c:dPt>
          <c:dPt>
            <c:idx val="5"/>
            <c:marker>
              <c:symbol val="circle"/>
              <c:size val="8"/>
              <c:spPr>
                <a:solidFill>
                  <a:srgbClr val="00B05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9133-4D4C-B155-0BF89F8B6D51}"/>
              </c:ext>
            </c:extLst>
          </c:dPt>
          <c:dPt>
            <c:idx val="6"/>
            <c:marker>
              <c:symbol val="square"/>
              <c:size val="8"/>
              <c:spPr>
                <a:solidFill>
                  <a:schemeClr val="accent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9133-4D4C-B155-0BF89F8B6D51}"/>
              </c:ext>
            </c:extLst>
          </c:dPt>
          <c:dPt>
            <c:idx val="7"/>
            <c:marker>
              <c:symbol val="square"/>
              <c:size val="8"/>
              <c:spPr>
                <a:solidFill>
                  <a:schemeClr val="accent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9133-4D4C-B155-0BF89F8B6D51}"/>
              </c:ext>
            </c:extLst>
          </c:dPt>
          <c:dPt>
            <c:idx val="8"/>
            <c:marker>
              <c:symbol val="square"/>
              <c:size val="8"/>
              <c:spPr>
                <a:solidFill>
                  <a:schemeClr val="accent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9133-4D4C-B155-0BF89F8B6D51}"/>
              </c:ext>
            </c:extLst>
          </c:dPt>
          <c:dPt>
            <c:idx val="9"/>
            <c:marker>
              <c:symbol val="square"/>
              <c:size val="8"/>
              <c:spPr>
                <a:solidFill>
                  <a:srgbClr val="00B05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9133-4D4C-B155-0BF89F8B6D51}"/>
              </c:ext>
            </c:extLst>
          </c:dPt>
          <c:dPt>
            <c:idx val="10"/>
            <c:marker>
              <c:symbol val="square"/>
              <c:size val="8"/>
              <c:spPr>
                <a:solidFill>
                  <a:srgbClr val="00B05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9133-4D4C-B155-0BF89F8B6D51}"/>
              </c:ext>
            </c:extLst>
          </c:dPt>
          <c:dPt>
            <c:idx val="11"/>
            <c:marker>
              <c:symbol val="square"/>
              <c:size val="8"/>
              <c:spPr>
                <a:solidFill>
                  <a:srgbClr val="00B05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9133-4D4C-B155-0BF89F8B6D51}"/>
              </c:ext>
            </c:extLst>
          </c:dPt>
          <c:xVal>
            <c:numRef>
              <c:f>Munka1!$B$6:$B$17</c:f>
              <c:numCache>
                <c:formatCode>General</c:formatCode>
                <c:ptCount val="12"/>
                <c:pt idx="0">
                  <c:v>-27.693239506959799</c:v>
                </c:pt>
                <c:pt idx="1">
                  <c:v>-27.018949492137999</c:v>
                </c:pt>
                <c:pt idx="2">
                  <c:v>-24.1242095308282</c:v>
                </c:pt>
                <c:pt idx="3">
                  <c:v>-21.429082140743599</c:v>
                </c:pt>
                <c:pt idx="4">
                  <c:v>-15.429957249280401</c:v>
                </c:pt>
                <c:pt idx="5">
                  <c:v>-18.741905654475701</c:v>
                </c:pt>
                <c:pt idx="6">
                  <c:v>-10.263238759506301</c:v>
                </c:pt>
                <c:pt idx="7">
                  <c:v>-6.3510858691912704</c:v>
                </c:pt>
                <c:pt idx="8">
                  <c:v>-8.3544117763979902</c:v>
                </c:pt>
                <c:pt idx="9">
                  <c:v>51.025187272008097</c:v>
                </c:pt>
                <c:pt idx="10">
                  <c:v>54.320776824486401</c:v>
                </c:pt>
                <c:pt idx="11">
                  <c:v>54.060115883026903</c:v>
                </c:pt>
              </c:numCache>
            </c:numRef>
          </c:xVal>
          <c:yVal>
            <c:numRef>
              <c:f>Munka1!$C$6:$C$17</c:f>
              <c:numCache>
                <c:formatCode>General</c:formatCode>
                <c:ptCount val="12"/>
                <c:pt idx="0">
                  <c:v>-1.1722346947823701</c:v>
                </c:pt>
                <c:pt idx="1">
                  <c:v>-2.9515472018015299</c:v>
                </c:pt>
                <c:pt idx="2">
                  <c:v>-0.96833401946839304</c:v>
                </c:pt>
                <c:pt idx="3">
                  <c:v>-21.7086686631947</c:v>
                </c:pt>
                <c:pt idx="4">
                  <c:v>-21.462223053702399</c:v>
                </c:pt>
                <c:pt idx="5">
                  <c:v>-19.5176470162219</c:v>
                </c:pt>
                <c:pt idx="6">
                  <c:v>26.038945467850802</c:v>
                </c:pt>
                <c:pt idx="7">
                  <c:v>27.5472686216997</c:v>
                </c:pt>
                <c:pt idx="8">
                  <c:v>26.201327206667901</c:v>
                </c:pt>
                <c:pt idx="9">
                  <c:v>-4.4045737628775896</c:v>
                </c:pt>
                <c:pt idx="10">
                  <c:v>-3.47242202981412</c:v>
                </c:pt>
                <c:pt idx="11">
                  <c:v>-4.12989085435537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913-4F60-816B-8F614A988B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759727296"/>
        <c:axId val="-1759724576"/>
      </c:scatterChart>
      <c:valAx>
        <c:axId val="-1759727296"/>
        <c:scaling>
          <c:orientation val="minMax"/>
          <c:max val="60"/>
          <c:min val="-6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hu-HU" b="1"/>
                  <a:t>PC1 (66.06% of variance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hu-HU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u-HU"/>
          </a:p>
        </c:txPr>
        <c:crossAx val="-1759724576"/>
        <c:crossesAt val="-60"/>
        <c:crossBetween val="midCat"/>
        <c:majorUnit val="20"/>
      </c:valAx>
      <c:valAx>
        <c:axId val="-1759724576"/>
        <c:scaling>
          <c:orientation val="minMax"/>
          <c:max val="60"/>
          <c:min val="-6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hu-HU" b="1"/>
                  <a:t>PC2</a:t>
                </a:r>
                <a:r>
                  <a:rPr lang="hu-HU" b="1" baseline="0"/>
                  <a:t> (19.54% of variance)</a:t>
                </a:r>
                <a:endParaRPr lang="hu-HU" b="1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hu-HU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u-HU"/>
          </a:p>
        </c:txPr>
        <c:crossAx val="-1759727296"/>
        <c:crossesAt val="-60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hu-HU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7029</cdr:x>
      <cdr:y>0.18033</cdr:y>
    </cdr:from>
    <cdr:to>
      <cdr:x>0.66519</cdr:x>
      <cdr:y>0.25246</cdr:y>
    </cdr:to>
    <cdr:sp macro="" textlink="">
      <cdr:nvSpPr>
        <cdr:cNvPr id="2" name="Szövegdoboz 1"/>
        <cdr:cNvSpPr txBox="1"/>
      </cdr:nvSpPr>
      <cdr:spPr>
        <a:xfrm xmlns:a="http://schemas.openxmlformats.org/drawingml/2006/main">
          <a:off x="1590674" y="785813"/>
          <a:ext cx="1266825" cy="314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hu-HU" sz="1200" i="1">
              <a:latin typeface="Symbol" panose="05050102010706020507" pitchFamily="18" charset="2"/>
              <a:cs typeface="Times New Roman" panose="02020603050405020304" pitchFamily="18" charset="0"/>
            </a:rPr>
            <a:t>D</a:t>
          </a:r>
          <a:r>
            <a:rPr lang="hu-HU" sz="1200" i="1">
              <a:latin typeface="Times New Roman" panose="02020603050405020304" pitchFamily="18" charset="0"/>
              <a:cs typeface="Times New Roman" panose="02020603050405020304" pitchFamily="18" charset="0"/>
            </a:rPr>
            <a:t>sodB</a:t>
          </a:r>
          <a:r>
            <a:rPr lang="hu-HU" sz="1200">
              <a:latin typeface="Times New Roman" panose="02020603050405020304" pitchFamily="18" charset="0"/>
              <a:cs typeface="Times New Roman" panose="02020603050405020304" pitchFamily="18" charset="0"/>
            </a:rPr>
            <a:t> untreated</a:t>
          </a:r>
        </a:p>
      </cdr:txBody>
    </cdr:sp>
  </cdr:relSizeAnchor>
  <cdr:relSizeAnchor xmlns:cdr="http://schemas.openxmlformats.org/drawingml/2006/chartDrawing">
    <cdr:from>
      <cdr:x>0.58389</cdr:x>
      <cdr:y>0.38761</cdr:y>
    </cdr:from>
    <cdr:to>
      <cdr:x>0.87879</cdr:x>
      <cdr:y>0.45974</cdr:y>
    </cdr:to>
    <cdr:sp macro="" textlink="">
      <cdr:nvSpPr>
        <cdr:cNvPr id="3" name="Szövegdoboz 1"/>
        <cdr:cNvSpPr txBox="1"/>
      </cdr:nvSpPr>
      <cdr:spPr>
        <a:xfrm xmlns:a="http://schemas.openxmlformats.org/drawingml/2006/main">
          <a:off x="2508250" y="1689100"/>
          <a:ext cx="1266825" cy="314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hu-HU" sz="1200" i="1">
              <a:latin typeface="Symbol" panose="05050102010706020507" pitchFamily="18" charset="2"/>
              <a:cs typeface="Times New Roman" panose="02020603050405020304" pitchFamily="18" charset="0"/>
            </a:rPr>
            <a:t>D</a:t>
          </a:r>
          <a:r>
            <a:rPr lang="hu-HU" sz="1200" i="1">
              <a:latin typeface="Times New Roman" panose="02020603050405020304" pitchFamily="18" charset="0"/>
              <a:cs typeface="Times New Roman" panose="02020603050405020304" pitchFamily="18" charset="0"/>
            </a:rPr>
            <a:t>sodB</a:t>
          </a:r>
          <a:r>
            <a:rPr lang="hu-HU" sz="1200">
              <a:latin typeface="Times New Roman" panose="02020603050405020304" pitchFamily="18" charset="0"/>
              <a:cs typeface="Times New Roman" panose="02020603050405020304" pitchFamily="18" charset="0"/>
            </a:rPr>
            <a:t> MSB treated</a:t>
          </a:r>
        </a:p>
      </cdr:txBody>
    </cdr:sp>
  </cdr:relSizeAnchor>
  <cdr:relSizeAnchor xmlns:cdr="http://schemas.openxmlformats.org/drawingml/2006/chartDrawing">
    <cdr:from>
      <cdr:x>0.34664</cdr:x>
      <cdr:y>0.60182</cdr:y>
    </cdr:from>
    <cdr:to>
      <cdr:x>0.64154</cdr:x>
      <cdr:y>0.67395</cdr:y>
    </cdr:to>
    <cdr:sp macro="" textlink="">
      <cdr:nvSpPr>
        <cdr:cNvPr id="4" name="Szövegdoboz 1"/>
        <cdr:cNvSpPr txBox="1"/>
      </cdr:nvSpPr>
      <cdr:spPr>
        <a:xfrm xmlns:a="http://schemas.openxmlformats.org/drawingml/2006/main">
          <a:off x="1489085" y="2622537"/>
          <a:ext cx="1266825" cy="3143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hu-HU" sz="1200">
              <a:latin typeface="Times New Roman" panose="02020603050405020304" pitchFamily="18" charset="0"/>
              <a:cs typeface="Times New Roman" panose="02020603050405020304" pitchFamily="18" charset="0"/>
            </a:rPr>
            <a:t>wt MSB treated</a:t>
          </a:r>
        </a:p>
      </cdr:txBody>
    </cdr:sp>
  </cdr:relSizeAnchor>
  <cdr:relSizeAnchor xmlns:cdr="http://schemas.openxmlformats.org/drawingml/2006/chartDrawing">
    <cdr:from>
      <cdr:x>0.29343</cdr:x>
      <cdr:y>0.36357</cdr:y>
    </cdr:from>
    <cdr:to>
      <cdr:x>0.58833</cdr:x>
      <cdr:y>0.4357</cdr:y>
    </cdr:to>
    <cdr:sp macro="" textlink="">
      <cdr:nvSpPr>
        <cdr:cNvPr id="5" name="Szövegdoboz 1"/>
        <cdr:cNvSpPr txBox="1"/>
      </cdr:nvSpPr>
      <cdr:spPr>
        <a:xfrm xmlns:a="http://schemas.openxmlformats.org/drawingml/2006/main">
          <a:off x="1260489" y="1584322"/>
          <a:ext cx="1266825" cy="3143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hu-HU" sz="1200">
              <a:latin typeface="Times New Roman" panose="02020603050405020304" pitchFamily="18" charset="0"/>
              <a:cs typeface="Times New Roman" panose="02020603050405020304" pitchFamily="18" charset="0"/>
            </a:rPr>
            <a:t>wt untreated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883861"/>
            <a:ext cx="5508149" cy="1880235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2836605"/>
            <a:ext cx="4860131" cy="1303913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hu-HU"/>
              <a:t>Alcím mintájának szerkesztés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E82F9-991A-401A-93A5-DA549A05A506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7A14D-D0E4-4F40-A900-231E07B6EE9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075088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E82F9-991A-401A-93A5-DA549A05A506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7A14D-D0E4-4F40-A900-231E07B6EE9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0092964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287536"/>
            <a:ext cx="1397288" cy="4576822"/>
          </a:xfrm>
        </p:spPr>
        <p:txBody>
          <a:bodyPr vert="eaVert"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287536"/>
            <a:ext cx="4110861" cy="4576822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E82F9-991A-401A-93A5-DA549A05A506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7A14D-D0E4-4F40-A900-231E07B6EE9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2351391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E82F9-991A-401A-93A5-DA549A05A506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7A14D-D0E4-4F40-A900-231E07B6EE9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6506095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1346420"/>
            <a:ext cx="5589151" cy="2246530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3614203"/>
            <a:ext cx="5589151" cy="1181397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E82F9-991A-401A-93A5-DA549A05A506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7A14D-D0E4-4F40-A900-231E07B6EE9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700901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1437680"/>
            <a:ext cx="2754074" cy="3426679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1437680"/>
            <a:ext cx="2754074" cy="3426679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E82F9-991A-401A-93A5-DA549A05A506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7A14D-D0E4-4F40-A900-231E07B6EE9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1733703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287537"/>
            <a:ext cx="5589151" cy="1043881"/>
          </a:xfrm>
        </p:spPr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1323916"/>
            <a:ext cx="2741417" cy="648831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1972747"/>
            <a:ext cx="2741417" cy="2901613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1323916"/>
            <a:ext cx="2754918" cy="648831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1972747"/>
            <a:ext cx="2754918" cy="2901613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E82F9-991A-401A-93A5-DA549A05A506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7A14D-D0E4-4F40-A900-231E07B6EE9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0599162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E82F9-991A-401A-93A5-DA549A05A506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7A14D-D0E4-4F40-A900-231E07B6EE9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534161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E82F9-991A-401A-93A5-DA549A05A506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7A14D-D0E4-4F40-A900-231E07B6EE9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8852795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360045"/>
            <a:ext cx="2090025" cy="1260158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777598"/>
            <a:ext cx="3280589" cy="3837980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620202"/>
            <a:ext cx="2090025" cy="3001626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E82F9-991A-401A-93A5-DA549A05A506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7A14D-D0E4-4F40-A900-231E07B6EE9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2557128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360045"/>
            <a:ext cx="2090025" cy="1260158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777598"/>
            <a:ext cx="3280589" cy="3837980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hu-HU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620202"/>
            <a:ext cx="2090025" cy="3001626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CE82F9-991A-401A-93A5-DA549A05A506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67A14D-D0E4-4F40-A900-231E07B6EE9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8423443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287537"/>
            <a:ext cx="5589151" cy="1043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1437680"/>
            <a:ext cx="5589151" cy="34266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5005627"/>
            <a:ext cx="1458039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CE82F9-991A-401A-93A5-DA549A05A506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5005627"/>
            <a:ext cx="2187059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5005627"/>
            <a:ext cx="1458039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67A14D-D0E4-4F40-A900-231E07B6EE9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4125426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Szövegdoboz 14"/>
          <p:cNvSpPr txBox="1"/>
          <p:nvPr/>
        </p:nvSpPr>
        <p:spPr>
          <a:xfrm>
            <a:off x="148543" y="4753713"/>
            <a:ext cx="619801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hu-HU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 S2.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incipal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onent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C)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NAseq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ta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lo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rated by the DESeq2 software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</p:txBody>
      </p:sp>
      <p:graphicFrame>
        <p:nvGraphicFramePr>
          <p:cNvPr id="16" name="Diagram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39384984"/>
              </p:ext>
            </p:extLst>
          </p:nvPr>
        </p:nvGraphicFramePr>
        <p:xfrm>
          <a:off x="972531" y="311463"/>
          <a:ext cx="4295776" cy="43576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4995092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46</Words>
  <Application>Microsoft Office PowerPoint</Application>
  <PresentationFormat>Egyéni</PresentationFormat>
  <Paragraphs>7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5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-téma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Tanar</dc:creator>
  <cp:lastModifiedBy>Pákozdi Klaudia Gréta</cp:lastModifiedBy>
  <cp:revision>14</cp:revision>
  <dcterms:created xsi:type="dcterms:W3CDTF">2023-02-11T18:00:10Z</dcterms:created>
  <dcterms:modified xsi:type="dcterms:W3CDTF">2024-09-09T15:37:47Z</dcterms:modified>
</cp:coreProperties>
</file>